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EB298"/>
    <a:srgbClr val="50D099"/>
    <a:srgbClr val="41DFC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150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CBF321-C2DB-44D0-B94F-DC33B0D6D13B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77BCE8-1075-4B39-BA4A-F4E8F5F8D8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19369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77BCE8-1075-4B39-BA4A-F4E8F5F8D8E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17090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3500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1163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760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604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8361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659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5542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9285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7318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909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0307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8B7380-FDC0-4B9F-9FBE-6930F6BDE76F}" type="datetimeFigureOut">
              <a:rPr kumimoji="1" lang="ja-JP" altLang="en-US" smtClean="0"/>
              <a:t>2024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610104-3C12-4AEA-93D7-F489A17247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33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B99C357E-19DF-6B59-941B-A5B21CB784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2562" y="837592"/>
            <a:ext cx="3366972" cy="2614958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59EADA85-D8C9-0CDD-E5A4-3FA0C5CACB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12443" y="826706"/>
            <a:ext cx="3366972" cy="2614958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9BE9D005-6F1C-627C-8EDB-72E715568DC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2561" y="3845958"/>
            <a:ext cx="3366972" cy="2614958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073003E9-4045-0545-A110-B34358D3884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12442" y="3856144"/>
            <a:ext cx="3366972" cy="2614958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F52F495-7894-4271-AC75-5CC333284D26}"/>
              </a:ext>
            </a:extLst>
          </p:cNvPr>
          <p:cNvSpPr txBox="1"/>
          <p:nvPr/>
        </p:nvSpPr>
        <p:spPr>
          <a:xfrm>
            <a:off x="1842124" y="3109940"/>
            <a:ext cx="25062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after operation (months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FE4C350-CFC2-694F-FBB8-BDE889F58DD0}"/>
              </a:ext>
            </a:extLst>
          </p:cNvPr>
          <p:cNvSpPr txBox="1"/>
          <p:nvPr/>
        </p:nvSpPr>
        <p:spPr>
          <a:xfrm>
            <a:off x="676505" y="499038"/>
            <a:ext cx="597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1BF6989-F4EA-6FA5-2419-A55EEBCC8C53}"/>
              </a:ext>
            </a:extLst>
          </p:cNvPr>
          <p:cNvSpPr txBox="1"/>
          <p:nvPr/>
        </p:nvSpPr>
        <p:spPr>
          <a:xfrm>
            <a:off x="4470200" y="499038"/>
            <a:ext cx="597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E32AAAD-1686-75F2-7E31-7D860CFC5390}"/>
              </a:ext>
            </a:extLst>
          </p:cNvPr>
          <p:cNvSpPr txBox="1"/>
          <p:nvPr/>
        </p:nvSpPr>
        <p:spPr>
          <a:xfrm rot="16200000">
            <a:off x="580203" y="1595243"/>
            <a:ext cx="14986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rat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62D69AD-34ED-73BD-ECEF-617B1A58B4F5}"/>
              </a:ext>
            </a:extLst>
          </p:cNvPr>
          <p:cNvSpPr txBox="1"/>
          <p:nvPr/>
        </p:nvSpPr>
        <p:spPr>
          <a:xfrm>
            <a:off x="2833883" y="1143876"/>
            <a:ext cx="22674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size 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≤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 mm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(n = 79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6431F78-C3D2-277C-3823-AFCF4D1FEAB6}"/>
              </a:ext>
            </a:extLst>
          </p:cNvPr>
          <p:cNvSpPr txBox="1"/>
          <p:nvPr/>
        </p:nvSpPr>
        <p:spPr>
          <a:xfrm rot="16200000">
            <a:off x="4318487" y="1595244"/>
            <a:ext cx="14986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rat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8EAE902-206C-FB8B-4932-1333A6D24BE6}"/>
              </a:ext>
            </a:extLst>
          </p:cNvPr>
          <p:cNvSpPr txBox="1"/>
          <p:nvPr/>
        </p:nvSpPr>
        <p:spPr>
          <a:xfrm rot="16200000">
            <a:off x="580204" y="4592022"/>
            <a:ext cx="14986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rat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7161DAC-C9D6-CF8C-EBFC-86DDA1A89F7E}"/>
              </a:ext>
            </a:extLst>
          </p:cNvPr>
          <p:cNvSpPr txBox="1"/>
          <p:nvPr/>
        </p:nvSpPr>
        <p:spPr>
          <a:xfrm rot="16200000">
            <a:off x="4318488" y="4592023"/>
            <a:ext cx="14986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rat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9A67766-A039-6E71-8539-2CF84605FEEE}"/>
              </a:ext>
            </a:extLst>
          </p:cNvPr>
          <p:cNvSpPr txBox="1"/>
          <p:nvPr/>
        </p:nvSpPr>
        <p:spPr>
          <a:xfrm>
            <a:off x="5616342" y="3109940"/>
            <a:ext cx="25062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after operation (months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A1F618E-AA94-DF1D-BE47-248847AA126A}"/>
              </a:ext>
            </a:extLst>
          </p:cNvPr>
          <p:cNvSpPr txBox="1"/>
          <p:nvPr/>
        </p:nvSpPr>
        <p:spPr>
          <a:xfrm>
            <a:off x="1842124" y="6128715"/>
            <a:ext cx="25062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after operation (months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727AF44-C14B-466D-E3D0-8336843109B0}"/>
              </a:ext>
            </a:extLst>
          </p:cNvPr>
          <p:cNvSpPr txBox="1"/>
          <p:nvPr/>
        </p:nvSpPr>
        <p:spPr>
          <a:xfrm>
            <a:off x="5616342" y="6128715"/>
            <a:ext cx="25062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after operation (months)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62E6F2F-F4B6-7123-0DC1-4165EF338782}"/>
              </a:ext>
            </a:extLst>
          </p:cNvPr>
          <p:cNvSpPr txBox="1"/>
          <p:nvPr/>
        </p:nvSpPr>
        <p:spPr>
          <a:xfrm>
            <a:off x="676505" y="3549860"/>
            <a:ext cx="597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71A6D5C-39FD-B9C1-67CC-5B1E7FAC761B}"/>
              </a:ext>
            </a:extLst>
          </p:cNvPr>
          <p:cNvSpPr txBox="1"/>
          <p:nvPr/>
        </p:nvSpPr>
        <p:spPr>
          <a:xfrm>
            <a:off x="4470200" y="3549860"/>
            <a:ext cx="597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13F1157-7BDA-F288-8793-F8982B163E46}"/>
              </a:ext>
            </a:extLst>
          </p:cNvPr>
          <p:cNvSpPr txBox="1"/>
          <p:nvPr/>
        </p:nvSpPr>
        <p:spPr>
          <a:xfrm>
            <a:off x="2372699" y="2447901"/>
            <a:ext cx="15357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size &gt; 19 mm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(n = 153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1129617A-AF1E-71E4-C7F5-DC3C5CCE609D}"/>
              </a:ext>
            </a:extLst>
          </p:cNvPr>
          <p:cNvSpPr txBox="1"/>
          <p:nvPr/>
        </p:nvSpPr>
        <p:spPr>
          <a:xfrm>
            <a:off x="6646103" y="1248218"/>
            <a:ext cx="22674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an-1 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≤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 U/ml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(n = 91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3CD6B29-D4CA-FDDF-0E78-07F5CD187801}"/>
              </a:ext>
            </a:extLst>
          </p:cNvPr>
          <p:cNvSpPr txBox="1"/>
          <p:nvPr/>
        </p:nvSpPr>
        <p:spPr>
          <a:xfrm>
            <a:off x="6495928" y="2424999"/>
            <a:ext cx="15508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an-1 &gt; 30 U/ml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(n = 139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148CDA4-9386-9F13-5952-ACC4C59F27E8}"/>
              </a:ext>
            </a:extLst>
          </p:cNvPr>
          <p:cNvSpPr txBox="1"/>
          <p:nvPr/>
        </p:nvSpPr>
        <p:spPr>
          <a:xfrm>
            <a:off x="3179532" y="4454858"/>
            <a:ext cx="12891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NI 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4.31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(n = 150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1A8DC3E9-1819-8DEB-4389-A8388E930EC1}"/>
              </a:ext>
            </a:extLst>
          </p:cNvPr>
          <p:cNvSpPr txBox="1"/>
          <p:nvPr/>
        </p:nvSpPr>
        <p:spPr>
          <a:xfrm>
            <a:off x="2481943" y="5458308"/>
            <a:ext cx="16518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NI &lt; 44.31 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(n = 82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047DA9EE-848C-C3A4-127F-EA3C61D0E29B}"/>
              </a:ext>
            </a:extLst>
          </p:cNvPr>
          <p:cNvSpPr txBox="1"/>
          <p:nvPr/>
        </p:nvSpPr>
        <p:spPr>
          <a:xfrm>
            <a:off x="6854353" y="4455637"/>
            <a:ext cx="1850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MR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≥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79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(n = 155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FA29E48-47C8-208C-D6D7-815811C6945D}"/>
              </a:ext>
            </a:extLst>
          </p:cNvPr>
          <p:cNvSpPr txBox="1"/>
          <p:nvPr/>
        </p:nvSpPr>
        <p:spPr>
          <a:xfrm>
            <a:off x="6259286" y="5516795"/>
            <a:ext cx="16621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MR &lt; 3.79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(n = 77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1FEC276-7B99-01C1-5D39-A93D85DFADC4}"/>
              </a:ext>
            </a:extLst>
          </p:cNvPr>
          <p:cNvSpPr txBox="1"/>
          <p:nvPr/>
        </p:nvSpPr>
        <p:spPr>
          <a:xfrm>
            <a:off x="3507580" y="902521"/>
            <a:ext cx="22674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0.00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BE611C3-5C7E-D038-2EF6-D61A08C98BC6}"/>
              </a:ext>
            </a:extLst>
          </p:cNvPr>
          <p:cNvSpPr txBox="1"/>
          <p:nvPr/>
        </p:nvSpPr>
        <p:spPr>
          <a:xfrm>
            <a:off x="7322367" y="902521"/>
            <a:ext cx="22674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0.00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6F0F75C-40AE-F946-DFB0-B32D79B5CFF6}"/>
              </a:ext>
            </a:extLst>
          </p:cNvPr>
          <p:cNvSpPr txBox="1"/>
          <p:nvPr/>
        </p:nvSpPr>
        <p:spPr>
          <a:xfrm>
            <a:off x="7322367" y="3935225"/>
            <a:ext cx="22674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0.00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AD0E762-6D05-E15C-1DEC-629F715A1B44}"/>
              </a:ext>
            </a:extLst>
          </p:cNvPr>
          <p:cNvSpPr txBox="1"/>
          <p:nvPr/>
        </p:nvSpPr>
        <p:spPr>
          <a:xfrm>
            <a:off x="3507580" y="3935225"/>
            <a:ext cx="22674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0.00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3643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2</TotalTime>
  <Words>139</Words>
  <Application>Microsoft Office PowerPoint</Application>
  <PresentationFormat>画面に合わせる (4:3)</PresentationFormat>
  <Paragraphs>3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西孝宜</dc:creator>
  <cp:lastModifiedBy>Takanori Konishi</cp:lastModifiedBy>
  <cp:revision>55</cp:revision>
  <dcterms:created xsi:type="dcterms:W3CDTF">2014-02-15T01:38:22Z</dcterms:created>
  <dcterms:modified xsi:type="dcterms:W3CDTF">2024-02-18T11:15:20Z</dcterms:modified>
</cp:coreProperties>
</file>